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A9859-A260-4FC5-9A50-6EF0D51238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CC360-E596-4D02-8B0A-0AD911F3F1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E7252-8CF5-4F8D-8194-C259E912F7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5AF69-F42A-4C35-9146-C88BE832BC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1F9FD-8178-436F-AEBB-AAD36084C8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BD68B-8589-49FC-8952-CA6E607A74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25866-328A-44F6-B6EC-7DBD42903C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17BC1-F293-4E18-A89C-DE9C5F42FD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B7558-CB20-407D-A04E-A105F9356C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7D939-F048-4276-A06D-1055D4EED2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263A9-1800-450D-B2DB-3314401669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C2574-EBE5-4D6E-A780-A053657795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78C08B-4CEF-435B-AF34-118242C7356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D:\D drive _Main\TKB\National Fellow project\Publication\Nature protocol_low cholesterol chicken\Nature protocol_low cholesterol chicken_revised\Semen\TC_10.tif"/>
          <p:cNvPicPr/>
          <p:nvPr/>
        </p:nvPicPr>
        <p:blipFill>
          <a:blip r:embed="rId1"/>
          <a:stretch/>
        </p:blipFill>
        <p:spPr>
          <a:xfrm>
            <a:off x="762120" y="762120"/>
            <a:ext cx="2743200" cy="20574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D:\D drive _Main\TKB\National Fellow project\Publication\Nature protocol_low cholesterol chicken\Nature protocol_low cholesterol chicken_revised\Semen\TC_8.tif"/>
          <p:cNvPicPr/>
          <p:nvPr/>
        </p:nvPicPr>
        <p:blipFill>
          <a:blip r:embed="rId2"/>
          <a:stretch/>
        </p:blipFill>
        <p:spPr>
          <a:xfrm>
            <a:off x="4572000" y="838080"/>
            <a:ext cx="2666880" cy="2000520"/>
          </a:xfrm>
          <a:prstGeom prst="rect">
            <a:avLst/>
          </a:prstGeom>
          <a:ln w="0">
            <a:noFill/>
          </a:ln>
        </p:spPr>
      </p:pic>
      <p:sp>
        <p:nvSpPr>
          <p:cNvPr id="43" name="TextBox 6"/>
          <p:cNvSpPr/>
          <p:nvPr/>
        </p:nvSpPr>
        <p:spPr>
          <a:xfrm>
            <a:off x="1752480" y="2971800"/>
            <a:ext cx="60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5715000" y="30481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1066680" y="3505320"/>
            <a:ext cx="6172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. Spermatozoa in transgenic male (a) and control male (b) birds at 30 weeks of age. Observed at 10X Magnifica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E:\Nature protocol_low cholesterol chicken_revised\Live and dead.jpg"/>
          <p:cNvPicPr/>
          <p:nvPr/>
        </p:nvPicPr>
        <p:blipFill>
          <a:blip r:embed="rId1"/>
          <a:stretch/>
        </p:blipFill>
        <p:spPr>
          <a:xfrm>
            <a:off x="1600200" y="1295280"/>
            <a:ext cx="5289480" cy="1646280"/>
          </a:xfrm>
          <a:prstGeom prst="rect">
            <a:avLst/>
          </a:prstGeom>
          <a:ln w="0">
            <a:noFill/>
          </a:ln>
        </p:spPr>
      </p:pic>
      <p:sp>
        <p:nvSpPr>
          <p:cNvPr id="47" name="TextBox 2"/>
          <p:cNvSpPr/>
          <p:nvPr/>
        </p:nvSpPr>
        <p:spPr>
          <a:xfrm>
            <a:off x="1066680" y="3505320"/>
            <a:ext cx="6172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. Live and dead sperm of transgenic chicken. Sperms are stained with eosin-nigrosin stain. * live sperm,       Dead sperm taking pink st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8" name="Straight Arrow Connector 4"/>
          <p:cNvCxnSpPr/>
          <p:nvPr/>
        </p:nvCxnSpPr>
        <p:spPr>
          <a:xfrm flipH="1">
            <a:off x="5257080" y="266652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9" name="Straight Arrow Connector 5"/>
          <p:cNvCxnSpPr/>
          <p:nvPr/>
        </p:nvCxnSpPr>
        <p:spPr>
          <a:xfrm flipH="1">
            <a:off x="4342680" y="175212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Straight Arrow Connector 7"/>
          <p:cNvCxnSpPr/>
          <p:nvPr/>
        </p:nvCxnSpPr>
        <p:spPr>
          <a:xfrm flipH="1">
            <a:off x="2742480" y="198072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1" name="5-Point Star 9"/>
          <p:cNvSpPr/>
          <p:nvPr/>
        </p:nvSpPr>
        <p:spPr>
          <a:xfrm>
            <a:off x="6477120" y="2133720"/>
            <a:ext cx="75960" cy="75960"/>
          </a:xfrm>
          <a:custGeom>
            <a:avLst/>
            <a:gdLst>
              <a:gd name="textAreaLeft" fmla="*/ 23400 w 75960"/>
              <a:gd name="textAreaRight" fmla="*/ 52560 w 75960"/>
              <a:gd name="textAreaTop" fmla="*/ 28800 h 75960"/>
              <a:gd name="textAreaBottom" fmla="*/ 57960 h 75960"/>
            </a:gdLst>
            <a:ahLst/>
            <a:rect l="textAreaLeft" t="textAreaTop" r="textAreaRight" b="textAreaBottom"/>
            <a:pathLst>
              <a:path w="76200" h="76200">
                <a:moveTo>
                  <a:pt x="0" y="29106"/>
                </a:moveTo>
                <a:lnTo>
                  <a:pt x="29106" y="29106"/>
                </a:lnTo>
                <a:lnTo>
                  <a:pt x="38100" y="0"/>
                </a:lnTo>
                <a:lnTo>
                  <a:pt x="47094" y="29106"/>
                </a:lnTo>
                <a:lnTo>
                  <a:pt x="76200" y="29106"/>
                </a:lnTo>
                <a:lnTo>
                  <a:pt x="52653" y="47094"/>
                </a:lnTo>
                <a:lnTo>
                  <a:pt x="61647" y="76200"/>
                </a:lnTo>
                <a:lnTo>
                  <a:pt x="38100" y="58211"/>
                </a:lnTo>
                <a:lnTo>
                  <a:pt x="14553" y="76200"/>
                </a:lnTo>
                <a:lnTo>
                  <a:pt x="23547" y="47094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7640" bIns="-17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5-Point Star 10"/>
          <p:cNvSpPr/>
          <p:nvPr/>
        </p:nvSpPr>
        <p:spPr>
          <a:xfrm>
            <a:off x="4114800" y="2362320"/>
            <a:ext cx="76320" cy="75960"/>
          </a:xfrm>
          <a:custGeom>
            <a:avLst/>
            <a:gdLst>
              <a:gd name="textAreaLeft" fmla="*/ 23400 w 76320"/>
              <a:gd name="textAreaRight" fmla="*/ 52920 w 76320"/>
              <a:gd name="textAreaTop" fmla="*/ 28800 h 75960"/>
              <a:gd name="textAreaBottom" fmla="*/ 57960 h 75960"/>
            </a:gdLst>
            <a:ahLst/>
            <a:rect l="textAreaLeft" t="textAreaTop" r="textAreaRight" b="textAreaBottom"/>
            <a:pathLst>
              <a:path w="76200" h="76200">
                <a:moveTo>
                  <a:pt x="0" y="29106"/>
                </a:moveTo>
                <a:lnTo>
                  <a:pt x="29106" y="29106"/>
                </a:lnTo>
                <a:lnTo>
                  <a:pt x="38100" y="0"/>
                </a:lnTo>
                <a:lnTo>
                  <a:pt x="47094" y="29106"/>
                </a:lnTo>
                <a:lnTo>
                  <a:pt x="76200" y="29106"/>
                </a:lnTo>
                <a:lnTo>
                  <a:pt x="52653" y="47094"/>
                </a:lnTo>
                <a:lnTo>
                  <a:pt x="61647" y="76200"/>
                </a:lnTo>
                <a:lnTo>
                  <a:pt x="38100" y="58211"/>
                </a:lnTo>
                <a:lnTo>
                  <a:pt x="14553" y="76200"/>
                </a:lnTo>
                <a:lnTo>
                  <a:pt x="23547" y="47094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7640" bIns="-17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5-Point Star 11"/>
          <p:cNvSpPr/>
          <p:nvPr/>
        </p:nvSpPr>
        <p:spPr>
          <a:xfrm>
            <a:off x="2819520" y="2438280"/>
            <a:ext cx="75960" cy="76320"/>
          </a:xfrm>
          <a:custGeom>
            <a:avLst/>
            <a:gdLst>
              <a:gd name="textAreaLeft" fmla="*/ 23400 w 75960"/>
              <a:gd name="textAreaRight" fmla="*/ 52560 w 75960"/>
              <a:gd name="textAreaTop" fmla="*/ 29160 h 76320"/>
              <a:gd name="textAreaBottom" fmla="*/ 58320 h 76320"/>
            </a:gdLst>
            <a:ahLst/>
            <a:rect l="textAreaLeft" t="textAreaTop" r="textAreaRight" b="textAreaBottom"/>
            <a:pathLst>
              <a:path w="76200" h="76200">
                <a:moveTo>
                  <a:pt x="0" y="29106"/>
                </a:moveTo>
                <a:lnTo>
                  <a:pt x="29106" y="29106"/>
                </a:lnTo>
                <a:lnTo>
                  <a:pt x="38100" y="0"/>
                </a:lnTo>
                <a:lnTo>
                  <a:pt x="47094" y="29106"/>
                </a:lnTo>
                <a:lnTo>
                  <a:pt x="76200" y="29106"/>
                </a:lnTo>
                <a:lnTo>
                  <a:pt x="52653" y="47094"/>
                </a:lnTo>
                <a:lnTo>
                  <a:pt x="61647" y="76200"/>
                </a:lnTo>
                <a:lnTo>
                  <a:pt x="38100" y="58211"/>
                </a:lnTo>
                <a:lnTo>
                  <a:pt x="14553" y="76200"/>
                </a:lnTo>
                <a:lnTo>
                  <a:pt x="23547" y="47094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7640" bIns="-17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15"/>
          <p:cNvCxnSpPr/>
          <p:nvPr/>
        </p:nvCxnSpPr>
        <p:spPr>
          <a:xfrm flipH="1">
            <a:off x="3276000" y="3812760"/>
            <a:ext cx="153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HP</dc:creator>
  <dc:description/>
  <dc:language>en-US</dc:language>
  <cp:lastModifiedBy>admin</cp:lastModifiedBy>
  <dcterms:modified xsi:type="dcterms:W3CDTF">2021-11-20T10:11:56Z</dcterms:modified>
  <cp:revision>63</cp:revision>
  <dc:subject/>
  <dc:title>Entry vector digestion with PvuI enzyme</dc:title>
</cp:coreProperties>
</file>